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5" r:id="rId2"/>
    <p:sldId id="267" r:id="rId3"/>
    <p:sldId id="272" r:id="rId4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堂國 良太" initials="堂國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18" autoAdjust="0"/>
    <p:restoredTop sz="94660"/>
  </p:normalViewPr>
  <p:slideViewPr>
    <p:cSldViewPr snapToGrid="0">
      <p:cViewPr varScale="1">
        <p:scale>
          <a:sx n="56" d="100"/>
          <a:sy n="56" d="100"/>
        </p:scale>
        <p:origin x="2190" y="12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200712&#27704;&#37326;&#36948;&#20063;\20190306&#27704;&#37326;&#36948;&#20063;\20190520&#27704;&#37326;&#36948;&#20063;\20180610&#27704;&#37326;&#36948;&#20063;\&#30740;&#31350;&#38306;&#20418;\SERPINE2\SERPINE2&#36039;&#26009;\20200722BMP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200712&#27704;&#37326;&#36948;&#20063;\20190306&#27704;&#37326;&#36948;&#20063;\20190520&#27704;&#37326;&#36948;&#20063;\20180610&#27704;&#37326;&#36948;&#20063;\&#30740;&#31350;&#38306;&#20418;\SERPINE2\SERPINE2&#36039;&#26009;\20200722BMP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E$2</c:f>
              <c:strCache>
                <c:ptCount val="1"/>
                <c:pt idx="0">
                  <c:v>nc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noFill/>
              <a:ln w="15875">
                <a:solidFill>
                  <a:schemeClr val="tx1"/>
                </a:solidFill>
              </a:ln>
              <a:effectLst/>
            </c:spPr>
          </c:marker>
          <c:cat>
            <c:strRef>
              <c:f>Sheet1!$F$1:$I$1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Sheet1!$F$2:$I$2</c:f>
              <c:numCache>
                <c:formatCode>General</c:formatCode>
                <c:ptCount val="4"/>
                <c:pt idx="0">
                  <c:v>0</c:v>
                </c:pt>
                <c:pt idx="1">
                  <c:v>0.27643486451465177</c:v>
                </c:pt>
                <c:pt idx="2">
                  <c:v>0.54780800127670726</c:v>
                </c:pt>
                <c:pt idx="3">
                  <c:v>0.8479469472647068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79D-42DE-AFD2-3A362EDB748F}"/>
            </c:ext>
          </c:extLst>
        </c:ser>
        <c:ser>
          <c:idx val="1"/>
          <c:order val="1"/>
          <c:tx>
            <c:strRef>
              <c:f>Sheet1!$E$3</c:f>
              <c:strCache>
                <c:ptCount val="1"/>
                <c:pt idx="0">
                  <c:v>#1</c:v>
                </c:pt>
              </c:strCache>
            </c:strRef>
          </c:tx>
          <c:spPr>
            <a:ln w="28575" cap="rnd">
              <a:solidFill>
                <a:sysClr val="windowText" lastClr="000000"/>
              </a:solidFill>
              <a:prstDash val="dash"/>
              <a:round/>
            </a:ln>
            <a:effectLst/>
          </c:spPr>
          <c:marker>
            <c:symbol val="diamond"/>
            <c:size val="6"/>
            <c:spPr>
              <a:noFill/>
              <a:ln w="15875">
                <a:solidFill>
                  <a:sysClr val="windowText" lastClr="000000"/>
                </a:solidFill>
              </a:ln>
              <a:effectLst/>
            </c:spPr>
          </c:marker>
          <c:cat>
            <c:strRef>
              <c:f>Sheet1!$F$1:$I$1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Sheet1!$F$3:$I$3</c:f>
              <c:numCache>
                <c:formatCode>General</c:formatCode>
                <c:ptCount val="4"/>
                <c:pt idx="0">
                  <c:v>0</c:v>
                </c:pt>
                <c:pt idx="1">
                  <c:v>0.34384816194739815</c:v>
                </c:pt>
                <c:pt idx="2">
                  <c:v>0.64099456532737331</c:v>
                </c:pt>
                <c:pt idx="3">
                  <c:v>0.7858194843244434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479D-42DE-AFD2-3A362EDB748F}"/>
            </c:ext>
          </c:extLst>
        </c:ser>
        <c:ser>
          <c:idx val="2"/>
          <c:order val="2"/>
          <c:tx>
            <c:strRef>
              <c:f>Sheet1!$E$4</c:f>
              <c:strCache>
                <c:ptCount val="1"/>
                <c:pt idx="0">
                  <c:v>#2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6"/>
            <c:spPr>
              <a:noFill/>
              <a:ln w="15875">
                <a:solidFill>
                  <a:schemeClr val="tx1"/>
                </a:solidFill>
              </a:ln>
              <a:effectLst/>
            </c:spPr>
          </c:marker>
          <c:cat>
            <c:strRef>
              <c:f>Sheet1!$F$1:$I$1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Sheet1!$F$4:$I$4</c:f>
              <c:numCache>
                <c:formatCode>General</c:formatCode>
                <c:ptCount val="4"/>
                <c:pt idx="0">
                  <c:v>0</c:v>
                </c:pt>
                <c:pt idx="1">
                  <c:v>0.32495670216231975</c:v>
                </c:pt>
                <c:pt idx="2">
                  <c:v>0.51237203559853906</c:v>
                </c:pt>
                <c:pt idx="3">
                  <c:v>0.7293649364679253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479D-42DE-AFD2-3A362EDB74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696327472"/>
        <c:axId val="-696326384"/>
      </c:lineChart>
      <c:catAx>
        <c:axId val="-696327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696326384"/>
        <c:crosses val="autoZero"/>
        <c:auto val="1"/>
        <c:lblAlgn val="ctr"/>
        <c:lblOffset val="100"/>
        <c:noMultiLvlLbl val="0"/>
      </c:catAx>
      <c:valAx>
        <c:axId val="-696326384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 dirty="0">
                    <a:solidFill>
                      <a:schemeClr val="tx1"/>
                    </a:solidFill>
                  </a:rPr>
                  <a:t>relative invaded area</a:t>
                </a:r>
                <a:endParaRPr lang="ja-JP" altLang="en-US" sz="120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696327472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PC9 invasion'!$E$2</c:f>
              <c:strCache>
                <c:ptCount val="1"/>
                <c:pt idx="0">
                  <c:v>nc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noFill/>
              <a:ln w="15875">
                <a:solidFill>
                  <a:schemeClr val="tx1"/>
                </a:solidFill>
              </a:ln>
              <a:effectLst/>
            </c:spPr>
          </c:marker>
          <c:cat>
            <c:strRef>
              <c:f>'PC9 invasion'!$F$1:$I$1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'PC9 invasion'!$F$2:$I$2</c:f>
              <c:numCache>
                <c:formatCode>General</c:formatCode>
                <c:ptCount val="4"/>
                <c:pt idx="0">
                  <c:v>0</c:v>
                </c:pt>
                <c:pt idx="1">
                  <c:v>3.7995948875867297E-2</c:v>
                </c:pt>
                <c:pt idx="2">
                  <c:v>0.25688373397721515</c:v>
                </c:pt>
                <c:pt idx="3">
                  <c:v>0.7298579006994155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8EAC-402A-93B4-B10F7C4DC3C6}"/>
            </c:ext>
          </c:extLst>
        </c:ser>
        <c:ser>
          <c:idx val="1"/>
          <c:order val="1"/>
          <c:tx>
            <c:strRef>
              <c:f>'PC9 invasion'!$E$3</c:f>
              <c:strCache>
                <c:ptCount val="1"/>
                <c:pt idx="0">
                  <c:v>#1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diamond"/>
            <c:size val="6"/>
            <c:spPr>
              <a:noFill/>
              <a:ln w="15875">
                <a:solidFill>
                  <a:schemeClr val="tx1"/>
                </a:solidFill>
              </a:ln>
              <a:effectLst/>
            </c:spPr>
          </c:marker>
          <c:cat>
            <c:strRef>
              <c:f>'PC9 invasion'!$F$1:$I$1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'PC9 invasion'!$F$3:$I$3</c:f>
              <c:numCache>
                <c:formatCode>General</c:formatCode>
                <c:ptCount val="4"/>
                <c:pt idx="0">
                  <c:v>0</c:v>
                </c:pt>
                <c:pt idx="1">
                  <c:v>7.1106230136043667E-3</c:v>
                </c:pt>
                <c:pt idx="2">
                  <c:v>4.2344003322461195E-2</c:v>
                </c:pt>
                <c:pt idx="3">
                  <c:v>0.4071405112628306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EAC-402A-93B4-B10F7C4DC3C6}"/>
            </c:ext>
          </c:extLst>
        </c:ser>
        <c:ser>
          <c:idx val="2"/>
          <c:order val="2"/>
          <c:tx>
            <c:strRef>
              <c:f>'PC9 invasion'!$E$4</c:f>
              <c:strCache>
                <c:ptCount val="1"/>
                <c:pt idx="0">
                  <c:v>#2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6"/>
            <c:spPr>
              <a:noFill/>
              <a:ln w="15875">
                <a:solidFill>
                  <a:schemeClr val="tx1"/>
                </a:solidFill>
              </a:ln>
              <a:effectLst/>
            </c:spPr>
          </c:marker>
          <c:cat>
            <c:strRef>
              <c:f>'PC9 invasion'!$F$1:$I$1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'PC9 invasion'!$F$4:$I$4</c:f>
              <c:numCache>
                <c:formatCode>General</c:formatCode>
                <c:ptCount val="4"/>
                <c:pt idx="0">
                  <c:v>0</c:v>
                </c:pt>
                <c:pt idx="1">
                  <c:v>6.946204228295573E-2</c:v>
                </c:pt>
                <c:pt idx="2">
                  <c:v>0.12760165350384819</c:v>
                </c:pt>
                <c:pt idx="3">
                  <c:v>0.1492705194444262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8EAC-402A-93B4-B10F7C4DC3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696325840"/>
        <c:axId val="-696325296"/>
      </c:lineChart>
      <c:catAx>
        <c:axId val="-696325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696325296"/>
        <c:crosses val="autoZero"/>
        <c:auto val="1"/>
        <c:lblAlgn val="ctr"/>
        <c:lblOffset val="100"/>
        <c:noMultiLvlLbl val="0"/>
      </c:catAx>
      <c:valAx>
        <c:axId val="-696325296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lang="ja-JP"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400" b="0" i="0" baseline="0" dirty="0">
                    <a:solidFill>
                      <a:schemeClr val="tx1"/>
                    </a:solidFill>
                    <a:effectLst/>
                  </a:rPr>
                  <a:t>relative invaded area</a:t>
                </a:r>
                <a:endParaRPr lang="ja-JP" altLang="ja-JP" sz="1400" dirty="0">
                  <a:solidFill>
                    <a:schemeClr val="tx1"/>
                  </a:solidFill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lang="ja-JP"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696325840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A549 migration'!$E$2</c:f>
              <c:strCache>
                <c:ptCount val="1"/>
                <c:pt idx="0">
                  <c:v>nc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noFill/>
              <a:ln w="15875">
                <a:solidFill>
                  <a:schemeClr val="tx1"/>
                </a:solidFill>
              </a:ln>
              <a:effectLst/>
            </c:spPr>
          </c:marker>
          <c:cat>
            <c:strRef>
              <c:f>'A549 migration'!$F$1:$I$1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'A549 migration'!$F$2:$I$2</c:f>
              <c:numCache>
                <c:formatCode>General</c:formatCode>
                <c:ptCount val="4"/>
                <c:pt idx="0">
                  <c:v>0</c:v>
                </c:pt>
                <c:pt idx="1">
                  <c:v>0.47535404803557912</c:v>
                </c:pt>
                <c:pt idx="2">
                  <c:v>0.67659686735408575</c:v>
                </c:pt>
                <c:pt idx="3">
                  <c:v>0.8673556561313362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655D-48D1-A94E-C0EDF695EAA1}"/>
            </c:ext>
          </c:extLst>
        </c:ser>
        <c:ser>
          <c:idx val="1"/>
          <c:order val="1"/>
          <c:tx>
            <c:strRef>
              <c:f>'A549 migration'!$E$3</c:f>
              <c:strCache>
                <c:ptCount val="1"/>
                <c:pt idx="0">
                  <c:v>#1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diamond"/>
            <c:size val="6"/>
            <c:spPr>
              <a:noFill/>
              <a:ln w="15875">
                <a:solidFill>
                  <a:schemeClr val="tx1"/>
                </a:solidFill>
              </a:ln>
              <a:effectLst/>
            </c:spPr>
          </c:marker>
          <c:cat>
            <c:strRef>
              <c:f>'A549 migration'!$F$1:$I$1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'A549 migration'!$F$3:$I$3</c:f>
              <c:numCache>
                <c:formatCode>General</c:formatCode>
                <c:ptCount val="4"/>
                <c:pt idx="0">
                  <c:v>0</c:v>
                </c:pt>
                <c:pt idx="1">
                  <c:v>0.42189297797374659</c:v>
                </c:pt>
                <c:pt idx="2">
                  <c:v>0.60690291913638772</c:v>
                </c:pt>
                <c:pt idx="3">
                  <c:v>0.8124600056984581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655D-48D1-A94E-C0EDF695EAA1}"/>
            </c:ext>
          </c:extLst>
        </c:ser>
        <c:ser>
          <c:idx val="2"/>
          <c:order val="2"/>
          <c:tx>
            <c:strRef>
              <c:f>'A549 migration'!$E$4</c:f>
              <c:strCache>
                <c:ptCount val="1"/>
                <c:pt idx="0">
                  <c:v>#2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6"/>
            <c:spPr>
              <a:noFill/>
              <a:ln w="15875">
                <a:solidFill>
                  <a:schemeClr val="tx1"/>
                </a:solidFill>
              </a:ln>
              <a:effectLst/>
            </c:spPr>
          </c:marker>
          <c:cat>
            <c:strRef>
              <c:f>'A549 migration'!$F$1:$I$1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'A549 migration'!$F$4:$I$4</c:f>
              <c:numCache>
                <c:formatCode>General</c:formatCode>
                <c:ptCount val="4"/>
                <c:pt idx="0">
                  <c:v>0</c:v>
                </c:pt>
                <c:pt idx="1">
                  <c:v>0.49243619575027164</c:v>
                </c:pt>
                <c:pt idx="2">
                  <c:v>0.60450420859400422</c:v>
                </c:pt>
                <c:pt idx="3">
                  <c:v>0.7538647847201330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655D-48D1-A94E-C0EDF695EA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696320400"/>
        <c:axId val="-1066175328"/>
      </c:lineChart>
      <c:catAx>
        <c:axId val="-696320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066175328"/>
        <c:crosses val="autoZero"/>
        <c:auto val="1"/>
        <c:lblAlgn val="ctr"/>
        <c:lblOffset val="100"/>
        <c:noMultiLvlLbl val="0"/>
      </c:catAx>
      <c:valAx>
        <c:axId val="-106617532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 dirty="0">
                    <a:solidFill>
                      <a:schemeClr val="tx1"/>
                    </a:solidFill>
                  </a:rPr>
                  <a:t>relative migrated area</a:t>
                </a:r>
                <a:endParaRPr lang="ja-JP" altLang="en-US" sz="120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696320400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PC9 migration'!$E$2</c:f>
              <c:strCache>
                <c:ptCount val="1"/>
                <c:pt idx="0">
                  <c:v>nc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noFill/>
              <a:ln w="15875">
                <a:solidFill>
                  <a:schemeClr val="tx1"/>
                </a:solidFill>
              </a:ln>
              <a:effectLst/>
            </c:spPr>
          </c:marker>
          <c:cat>
            <c:strRef>
              <c:f>'PC9 migration'!$F$1:$I$1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'PC9 migration'!$F$2:$I$2</c:f>
              <c:numCache>
                <c:formatCode>General</c:formatCode>
                <c:ptCount val="4"/>
                <c:pt idx="0">
                  <c:v>0</c:v>
                </c:pt>
                <c:pt idx="1">
                  <c:v>0.49395783588608699</c:v>
                </c:pt>
                <c:pt idx="2">
                  <c:v>0.86549633102323686</c:v>
                </c:pt>
                <c:pt idx="3">
                  <c:v>0.9994758604624075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D519-48FD-B387-73E24B044B6C}"/>
            </c:ext>
          </c:extLst>
        </c:ser>
        <c:ser>
          <c:idx val="1"/>
          <c:order val="1"/>
          <c:tx>
            <c:strRef>
              <c:f>'PC9 migration'!$E$3</c:f>
              <c:strCache>
                <c:ptCount val="1"/>
                <c:pt idx="0">
                  <c:v>#1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diamond"/>
            <c:size val="6"/>
            <c:spPr>
              <a:noFill/>
              <a:ln w="15875">
                <a:solidFill>
                  <a:schemeClr val="tx1"/>
                </a:solidFill>
              </a:ln>
              <a:effectLst/>
            </c:spPr>
          </c:marker>
          <c:cat>
            <c:strRef>
              <c:f>'PC9 migration'!$F$1:$I$1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'PC9 migration'!$F$3:$I$3</c:f>
              <c:numCache>
                <c:formatCode>General</c:formatCode>
                <c:ptCount val="4"/>
                <c:pt idx="0">
                  <c:v>0</c:v>
                </c:pt>
                <c:pt idx="1">
                  <c:v>0.68830744988412607</c:v>
                </c:pt>
                <c:pt idx="2">
                  <c:v>0.93763412857222916</c:v>
                </c:pt>
                <c:pt idx="3">
                  <c:v>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519-48FD-B387-73E24B044B6C}"/>
            </c:ext>
          </c:extLst>
        </c:ser>
        <c:ser>
          <c:idx val="2"/>
          <c:order val="2"/>
          <c:tx>
            <c:strRef>
              <c:f>'PC9 migration'!$E$4</c:f>
              <c:strCache>
                <c:ptCount val="1"/>
                <c:pt idx="0">
                  <c:v>#2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triangle"/>
            <c:size val="6"/>
            <c:spPr>
              <a:noFill/>
              <a:ln w="15875">
                <a:solidFill>
                  <a:schemeClr val="tx1"/>
                </a:solidFill>
              </a:ln>
              <a:effectLst/>
            </c:spPr>
          </c:marker>
          <c:cat>
            <c:strRef>
              <c:f>'PC9 migration'!$F$1:$I$1</c:f>
              <c:strCache>
                <c:ptCount val="4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  <c:pt idx="3">
                  <c:v>72h</c:v>
                </c:pt>
              </c:strCache>
            </c:strRef>
          </c:cat>
          <c:val>
            <c:numRef>
              <c:f>'PC9 migration'!$F$4:$I$4</c:f>
              <c:numCache>
                <c:formatCode>General</c:formatCode>
                <c:ptCount val="4"/>
                <c:pt idx="0">
                  <c:v>0</c:v>
                </c:pt>
                <c:pt idx="1">
                  <c:v>0.4614675531002464</c:v>
                </c:pt>
                <c:pt idx="2">
                  <c:v>0.84571791340760183</c:v>
                </c:pt>
                <c:pt idx="3">
                  <c:v>0.9983375362511682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D519-48FD-B387-73E24B044B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621252512"/>
        <c:axId val="-621248160"/>
      </c:lineChart>
      <c:catAx>
        <c:axId val="-6212525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621248160"/>
        <c:crosses val="autoZero"/>
        <c:auto val="1"/>
        <c:lblAlgn val="ctr"/>
        <c:lblOffset val="100"/>
        <c:noMultiLvlLbl val="0"/>
      </c:catAx>
      <c:valAx>
        <c:axId val="-621248160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relative migrated area</a:t>
                </a:r>
                <a:endParaRPr lang="ja-JP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6212525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 sz="1000" b="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000" b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ja-JP" altLang="en-US" sz="1000" b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I$35:$I$37</c:f>
                <c:numCache>
                  <c:formatCode>General</c:formatCode>
                  <c:ptCount val="3"/>
                  <c:pt idx="0">
                    <c:v>6.8936819999999996E-2</c:v>
                  </c:pt>
                  <c:pt idx="1">
                    <c:v>7.1318030000000004E-2</c:v>
                  </c:pt>
                  <c:pt idx="2">
                    <c:v>5.47222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Relative Quantity Chart'!$K$38:$K$40</c:f>
              <c:strCache>
                <c:ptCount val="3"/>
                <c:pt idx="0">
                  <c:v>nc</c:v>
                </c:pt>
                <c:pt idx="1">
                  <c:v>#1</c:v>
                </c:pt>
                <c:pt idx="2">
                  <c:v>#2</c:v>
                </c:pt>
              </c:strCache>
            </c:strRef>
          </c:cat>
          <c:val>
            <c:numRef>
              <c:f>'Relative Quantity Chart'!$L$38:$L$40</c:f>
              <c:numCache>
                <c:formatCode>General</c:formatCode>
                <c:ptCount val="3"/>
                <c:pt idx="0">
                  <c:v>1</c:v>
                </c:pt>
                <c:pt idx="1">
                  <c:v>0.81413093771533973</c:v>
                </c:pt>
                <c:pt idx="2">
                  <c:v>1.04729339410050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E8E-4832-B4E0-32900517F1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621259040"/>
        <c:axId val="-621249792"/>
      </c:barChart>
      <c:catAx>
        <c:axId val="-62125904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621249792"/>
        <c:crosses val="autoZero"/>
        <c:auto val="1"/>
        <c:lblAlgn val="ctr"/>
        <c:lblOffset val="100"/>
        <c:noMultiLvlLbl val="0"/>
      </c:catAx>
      <c:valAx>
        <c:axId val="-62124979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lang="ja-JP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ja-JP" b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altLang="ja-JP" b="0" i="1">
                    <a:latin typeface="Arial" panose="020B0604020202020204" pitchFamily="34" charset="0"/>
                    <a:cs typeface="Arial" panose="020B0604020202020204" pitchFamily="34" charset="0"/>
                  </a:rPr>
                  <a:t>BMP4</a:t>
                </a:r>
                <a:r>
                  <a:rPr lang="en-US" altLang="ja-JP" b="0">
                    <a:latin typeface="Arial" panose="020B0604020202020204" pitchFamily="34" charset="0"/>
                    <a:cs typeface="Arial" panose="020B0604020202020204" pitchFamily="34" charset="0"/>
                  </a:rPr>
                  <a:t> expression</a:t>
                </a:r>
                <a:endParaRPr lang="ja-JP" altLang="en-US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621259040"/>
        <c:crosses val="autoZero"/>
        <c:crossBetween val="between"/>
      </c:valAx>
    </c:plotArea>
    <c:plotVisOnly val="1"/>
    <c:dispBlanksAs val="gap"/>
    <c:showDLblsOverMax val="0"/>
  </c:chart>
  <c:spPr>
    <a:ln w="12700"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 sz="1000" b="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en-US" sz="1000" b="0">
                <a:latin typeface="Arial" panose="020B0604020202020204" pitchFamily="34" charset="0"/>
                <a:cs typeface="Arial" panose="020B0604020202020204" pitchFamily="34" charset="0"/>
              </a:rPr>
              <a:t>PC9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Relative Quantity Chart'!$I$41:$I$43</c:f>
                <c:numCache>
                  <c:formatCode>General</c:formatCode>
                  <c:ptCount val="3"/>
                  <c:pt idx="0">
                    <c:v>7.1921230000000003E-2</c:v>
                  </c:pt>
                  <c:pt idx="1">
                    <c:v>0.11843919999999999</c:v>
                  </c:pt>
                  <c:pt idx="2">
                    <c:v>6.515740999999999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Relative Quantity Chart'!$K$41:$K$43</c:f>
              <c:strCache>
                <c:ptCount val="3"/>
                <c:pt idx="0">
                  <c:v>nc</c:v>
                </c:pt>
                <c:pt idx="1">
                  <c:v>#1</c:v>
                </c:pt>
                <c:pt idx="2">
                  <c:v>#2</c:v>
                </c:pt>
              </c:strCache>
            </c:strRef>
          </c:cat>
          <c:val>
            <c:numRef>
              <c:f>'Relative Quantity Chart'!$L$41:$L$43</c:f>
              <c:numCache>
                <c:formatCode>General</c:formatCode>
                <c:ptCount val="3"/>
                <c:pt idx="0">
                  <c:v>1</c:v>
                </c:pt>
                <c:pt idx="1">
                  <c:v>0.8685399075139193</c:v>
                </c:pt>
                <c:pt idx="2">
                  <c:v>0.850668197266642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CCC-4525-B9F3-75E4BEEB16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621246528"/>
        <c:axId val="-621249248"/>
      </c:barChart>
      <c:catAx>
        <c:axId val="-62124652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621249248"/>
        <c:crosses val="autoZero"/>
        <c:auto val="1"/>
        <c:lblAlgn val="ctr"/>
        <c:lblOffset val="100"/>
        <c:noMultiLvlLbl val="0"/>
      </c:catAx>
      <c:valAx>
        <c:axId val="-621249248"/>
        <c:scaling>
          <c:orientation val="minMax"/>
          <c:min val="0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lang="ja-JP" sz="10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ja-JP" sz="10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altLang="ja-JP" sz="1000" b="0" i="1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BMP4</a:t>
                </a:r>
                <a:r>
                  <a:rPr lang="en-US" altLang="ja-JP" sz="10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 expression</a:t>
                </a:r>
                <a:endParaRPr lang="ja-JP" altLang="ja-JP" sz="100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6212465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BC3E-C675-43E3-801F-DC74CF8EA8E4}" type="datetimeFigureOut">
              <a:rPr kumimoji="1" lang="ja-JP" altLang="en-US" smtClean="0"/>
              <a:t>2020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FD51D-3A21-4871-98E9-61854F6A38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7593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BC3E-C675-43E3-801F-DC74CF8EA8E4}" type="datetimeFigureOut">
              <a:rPr kumimoji="1" lang="ja-JP" altLang="en-US" smtClean="0"/>
              <a:t>2020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FD51D-3A21-4871-98E9-61854F6A38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10902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BC3E-C675-43E3-801F-DC74CF8EA8E4}" type="datetimeFigureOut">
              <a:rPr kumimoji="1" lang="ja-JP" altLang="en-US" smtClean="0"/>
              <a:t>2020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FD51D-3A21-4871-98E9-61854F6A38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3836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BC3E-C675-43E3-801F-DC74CF8EA8E4}" type="datetimeFigureOut">
              <a:rPr kumimoji="1" lang="ja-JP" altLang="en-US" smtClean="0"/>
              <a:t>2020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FD51D-3A21-4871-98E9-61854F6A38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36203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BC3E-C675-43E3-801F-DC74CF8EA8E4}" type="datetimeFigureOut">
              <a:rPr kumimoji="1" lang="ja-JP" altLang="en-US" smtClean="0"/>
              <a:t>2020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FD51D-3A21-4871-98E9-61854F6A38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0696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BC3E-C675-43E3-801F-DC74CF8EA8E4}" type="datetimeFigureOut">
              <a:rPr kumimoji="1" lang="ja-JP" altLang="en-US" smtClean="0"/>
              <a:t>2020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FD51D-3A21-4871-98E9-61854F6A38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8434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BC3E-C675-43E3-801F-DC74CF8EA8E4}" type="datetimeFigureOut">
              <a:rPr kumimoji="1" lang="ja-JP" altLang="en-US" smtClean="0"/>
              <a:t>2020/12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FD51D-3A21-4871-98E9-61854F6A38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71981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BC3E-C675-43E3-801F-DC74CF8EA8E4}" type="datetimeFigureOut">
              <a:rPr kumimoji="1" lang="ja-JP" altLang="en-US" smtClean="0"/>
              <a:t>2020/12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FD51D-3A21-4871-98E9-61854F6A38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2290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BC3E-C675-43E3-801F-DC74CF8EA8E4}" type="datetimeFigureOut">
              <a:rPr kumimoji="1" lang="ja-JP" altLang="en-US" smtClean="0"/>
              <a:t>2020/12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FD51D-3A21-4871-98E9-61854F6A38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3103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BC3E-C675-43E3-801F-DC74CF8EA8E4}" type="datetimeFigureOut">
              <a:rPr kumimoji="1" lang="ja-JP" altLang="en-US" smtClean="0"/>
              <a:t>2020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FD51D-3A21-4871-98E9-61854F6A38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6762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BC3E-C675-43E3-801F-DC74CF8EA8E4}" type="datetimeFigureOut">
              <a:rPr kumimoji="1" lang="ja-JP" altLang="en-US" smtClean="0"/>
              <a:t>2020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FD51D-3A21-4871-98E9-61854F6A38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3509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C4BC3E-C675-43E3-801F-DC74CF8EA8E4}" type="datetimeFigureOut">
              <a:rPr kumimoji="1" lang="ja-JP" altLang="en-US" smtClean="0"/>
              <a:t>2020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AFD51D-3A21-4871-98E9-61854F6A38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1038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23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Relationship Id="rId22" Type="http://schemas.openxmlformats.org/officeDocument/2006/relationships/image" Target="../media/image2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0FAD719A-D63F-450D-92CE-9F655EB23738}"/>
              </a:ext>
            </a:extLst>
          </p:cNvPr>
          <p:cNvSpPr txBox="1"/>
          <p:nvPr/>
        </p:nvSpPr>
        <p:spPr>
          <a:xfrm rot="16200000">
            <a:off x="-358429" y="1325635"/>
            <a:ext cx="1185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err="1"/>
              <a:t>negacon</a:t>
            </a:r>
            <a:endParaRPr kumimoji="1" lang="ja-JP" altLang="en-US" sz="12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539940B0-1386-46B4-BB67-3B62EE47CDEF}"/>
              </a:ext>
            </a:extLst>
          </p:cNvPr>
          <p:cNvSpPr txBox="1"/>
          <p:nvPr/>
        </p:nvSpPr>
        <p:spPr>
          <a:xfrm rot="16200000">
            <a:off x="-339843" y="2498026"/>
            <a:ext cx="114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siRNA#1</a:t>
            </a:r>
            <a:endParaRPr kumimoji="1" lang="ja-JP" altLang="en-US" sz="12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F5069FE4-2B6A-494D-B3DA-B874E1F01A0C}"/>
              </a:ext>
            </a:extLst>
          </p:cNvPr>
          <p:cNvSpPr txBox="1"/>
          <p:nvPr/>
        </p:nvSpPr>
        <p:spPr>
          <a:xfrm rot="16200000">
            <a:off x="-372730" y="3587160"/>
            <a:ext cx="121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siRNA#2</a:t>
            </a:r>
            <a:endParaRPr kumimoji="1" lang="ja-JP" altLang="en-US" sz="1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AB2EC2E6-35BD-4751-AF9F-CFD39954D0F9}"/>
              </a:ext>
            </a:extLst>
          </p:cNvPr>
          <p:cNvSpPr txBox="1"/>
          <p:nvPr/>
        </p:nvSpPr>
        <p:spPr>
          <a:xfrm>
            <a:off x="1000639" y="645819"/>
            <a:ext cx="8295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0h</a:t>
            </a:r>
            <a:endParaRPr kumimoji="1" lang="ja-JP" altLang="en-US" sz="12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1698730C-489B-4E3C-A76A-D8F3A7F37B6E}"/>
              </a:ext>
            </a:extLst>
          </p:cNvPr>
          <p:cNvSpPr txBox="1"/>
          <p:nvPr/>
        </p:nvSpPr>
        <p:spPr>
          <a:xfrm>
            <a:off x="2395534" y="645819"/>
            <a:ext cx="14234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24h</a:t>
            </a:r>
            <a:endParaRPr kumimoji="1" lang="ja-JP" altLang="en-US" sz="1200" dirty="0"/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xmlns="" id="{5DF12E82-74C0-44D7-990B-E049641257E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995" y="962028"/>
            <a:ext cx="1530373" cy="11477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xmlns="" id="{BB1DE78B-3596-477B-B136-8AB298DFA25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8368" y="961439"/>
            <a:ext cx="1530373" cy="11477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xmlns="" id="{7C3612A3-F1E1-4A20-A996-F5FD7278D11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8742" y="962028"/>
            <a:ext cx="1530373" cy="11477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xmlns="" id="{88281577-D25C-465B-9046-246329BD064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132" y="2109219"/>
            <a:ext cx="1530373" cy="11477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xmlns="" id="{E3D20E6B-27A6-44C9-B7E3-2FB5E52AF2B7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7380" y="2108630"/>
            <a:ext cx="1530373" cy="11477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xmlns="" id="{F379B3BA-9D22-40F2-A02F-A73B12A1546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7754" y="2105407"/>
            <a:ext cx="1530373" cy="11477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xmlns="" id="{F263B872-154E-44BE-A5FA-7B515A01FD74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7139" y="2105407"/>
            <a:ext cx="1530373" cy="11477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xmlns="" id="{729D7DC5-C312-41B0-B105-3796669916FC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9115" y="962028"/>
            <a:ext cx="1530373" cy="11477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xmlns="" id="{D3303221-1E58-44C8-89B9-D11C4924803C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132" y="3253187"/>
            <a:ext cx="1530373" cy="11477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xmlns="" id="{3AD499A8-4666-416A-AFFB-E33E074AB0AD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9676" y="3248786"/>
            <a:ext cx="1530373" cy="11477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xmlns="" id="{F9FD5BC0-7C52-47DE-97B7-1A8A2254F4E6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9229" y="3252505"/>
            <a:ext cx="1530373" cy="11477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xmlns="" id="{DDAFD534-DB18-4C7F-A22F-8D6E627F7C3F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7566" y="3249715"/>
            <a:ext cx="1530373" cy="11477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C9C48635-4B6F-4509-B943-2B161BC22853}"/>
              </a:ext>
            </a:extLst>
          </p:cNvPr>
          <p:cNvSpPr txBox="1"/>
          <p:nvPr/>
        </p:nvSpPr>
        <p:spPr>
          <a:xfrm>
            <a:off x="3917152" y="645819"/>
            <a:ext cx="14234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48h</a:t>
            </a:r>
            <a:endParaRPr kumimoji="1" lang="ja-JP" altLang="en-US" sz="1200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9583A953-28E8-4FBD-8A91-E14A7C0AAE9B}"/>
              </a:ext>
            </a:extLst>
          </p:cNvPr>
          <p:cNvSpPr txBox="1"/>
          <p:nvPr/>
        </p:nvSpPr>
        <p:spPr>
          <a:xfrm>
            <a:off x="5447525" y="645819"/>
            <a:ext cx="14234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72h</a:t>
            </a:r>
            <a:endParaRPr kumimoji="1" lang="ja-JP" altLang="en-US" sz="1200" dirty="0"/>
          </a:p>
        </p:txBody>
      </p:sp>
      <p:pic>
        <p:nvPicPr>
          <p:cNvPr id="32" name="図 31">
            <a:extLst>
              <a:ext uri="{FF2B5EF4-FFF2-40B4-BE49-F238E27FC236}">
                <a16:creationId xmlns:a16="http://schemas.microsoft.com/office/drawing/2014/main" xmlns="" id="{AEE9BB2E-577B-47B4-A401-C4EB394D8C0E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080" y="5057391"/>
            <a:ext cx="1531596" cy="11486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xmlns="" id="{8588A076-3517-4A45-A4A0-C17AE4958A1D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9675" y="5057391"/>
            <a:ext cx="1531596" cy="11486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xmlns="" id="{41E1745F-2018-4F08-A530-E37FC0C141D3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1271" y="5057391"/>
            <a:ext cx="1531596" cy="11486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xmlns="" id="{26625EA1-76EA-41CC-8275-B2B48A29E9B6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2866" y="5057391"/>
            <a:ext cx="1531596" cy="11486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xmlns="" id="{F3C20758-5760-4115-A782-7749D68CA4B3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080" y="6206087"/>
            <a:ext cx="1531596" cy="11486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xmlns="" id="{6B9DBABD-E34F-4A2B-8106-D5505A87726B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9675" y="6206087"/>
            <a:ext cx="1531596" cy="11486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xmlns="" id="{2C4E68B0-85D3-4A66-9FC9-1DB062459705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1356" y="6205100"/>
            <a:ext cx="1531596" cy="11486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xmlns="" id="{C901F517-7D87-4723-8C1C-8DD952608DC8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4409" y="6205100"/>
            <a:ext cx="1531596" cy="11486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xmlns="" id="{2D4F7FA8-FCA5-4CA2-917A-E7A9EC7C0F70}"/>
              </a:ext>
            </a:extLst>
          </p:cNvPr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995" y="7352809"/>
            <a:ext cx="1531596" cy="11486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xmlns="" id="{9371C950-8C5E-43A8-811C-7C5B21B706E4}"/>
              </a:ext>
            </a:extLst>
          </p:cNvPr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9591" y="7352809"/>
            <a:ext cx="1531596" cy="11486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xmlns="" id="{432077DC-94BE-4C62-8FF2-327F99ABFA17}"/>
              </a:ext>
            </a:extLst>
          </p:cNvPr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1271" y="7352809"/>
            <a:ext cx="1531596" cy="11486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xmlns="" id="{628B338A-ED1A-4054-8885-ECE2A7D4B076}"/>
              </a:ext>
            </a:extLst>
          </p:cNvPr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4409" y="7352809"/>
            <a:ext cx="1531596" cy="114869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xmlns="" id="{F3A98B27-F7D8-4238-9E6B-2DE83E667D30}"/>
              </a:ext>
            </a:extLst>
          </p:cNvPr>
          <p:cNvSpPr txBox="1"/>
          <p:nvPr/>
        </p:nvSpPr>
        <p:spPr>
          <a:xfrm>
            <a:off x="949690" y="4690033"/>
            <a:ext cx="8295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0h</a:t>
            </a:r>
            <a:endParaRPr kumimoji="1" lang="ja-JP" altLang="en-US" sz="1200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xmlns="" id="{EF319850-E947-4198-8705-29925D9597B6}"/>
              </a:ext>
            </a:extLst>
          </p:cNvPr>
          <p:cNvSpPr txBox="1"/>
          <p:nvPr/>
        </p:nvSpPr>
        <p:spPr>
          <a:xfrm>
            <a:off x="2344585" y="4690033"/>
            <a:ext cx="14234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24h</a:t>
            </a:r>
            <a:endParaRPr kumimoji="1" lang="ja-JP" altLang="en-US" sz="1200" dirty="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xmlns="" id="{31BDC542-ECA9-40C0-9110-EA8C16DFF3D8}"/>
              </a:ext>
            </a:extLst>
          </p:cNvPr>
          <p:cNvSpPr txBox="1"/>
          <p:nvPr/>
        </p:nvSpPr>
        <p:spPr>
          <a:xfrm>
            <a:off x="3866203" y="4690033"/>
            <a:ext cx="14234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48h</a:t>
            </a:r>
            <a:endParaRPr kumimoji="1" lang="ja-JP" altLang="en-US" sz="1200" dirty="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6FBD6EE1-CB97-4990-B187-1FD2B7B2E56A}"/>
              </a:ext>
            </a:extLst>
          </p:cNvPr>
          <p:cNvSpPr txBox="1"/>
          <p:nvPr/>
        </p:nvSpPr>
        <p:spPr>
          <a:xfrm>
            <a:off x="5396576" y="4690033"/>
            <a:ext cx="14234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72h</a:t>
            </a:r>
            <a:endParaRPr kumimoji="1" lang="ja-JP" altLang="en-US" sz="1200" dirty="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xmlns="" id="{5FB40B16-CAE7-46E6-B911-CDBF67F5AF88}"/>
              </a:ext>
            </a:extLst>
          </p:cNvPr>
          <p:cNvSpPr txBox="1"/>
          <p:nvPr/>
        </p:nvSpPr>
        <p:spPr>
          <a:xfrm rot="16200000">
            <a:off x="-379700" y="5480498"/>
            <a:ext cx="1185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err="1"/>
              <a:t>negacon</a:t>
            </a:r>
            <a:endParaRPr kumimoji="1" lang="ja-JP" altLang="en-US" sz="1200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xmlns="" id="{7DF42682-0CBC-4984-884B-FDF38BDF9665}"/>
              </a:ext>
            </a:extLst>
          </p:cNvPr>
          <p:cNvSpPr txBox="1"/>
          <p:nvPr/>
        </p:nvSpPr>
        <p:spPr>
          <a:xfrm rot="16200000">
            <a:off x="-361114" y="6652889"/>
            <a:ext cx="114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siRNA#1</a:t>
            </a:r>
            <a:endParaRPr kumimoji="1" lang="ja-JP" altLang="en-US" sz="1200" dirty="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xmlns="" id="{1B95EB65-1476-4ACC-8AC4-3DC54CBDED34}"/>
              </a:ext>
            </a:extLst>
          </p:cNvPr>
          <p:cNvSpPr txBox="1"/>
          <p:nvPr/>
        </p:nvSpPr>
        <p:spPr>
          <a:xfrm rot="16200000">
            <a:off x="-394001" y="7742023"/>
            <a:ext cx="121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siRNA#2</a:t>
            </a:r>
            <a:endParaRPr kumimoji="1" lang="ja-JP" altLang="en-US" sz="1200" dirty="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xmlns="" id="{6764E804-00D2-4E52-A9D8-D37B09FDF386}"/>
              </a:ext>
            </a:extLst>
          </p:cNvPr>
          <p:cNvSpPr txBox="1"/>
          <p:nvPr/>
        </p:nvSpPr>
        <p:spPr>
          <a:xfrm>
            <a:off x="2982409" y="-384338"/>
            <a:ext cx="47163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A549</a:t>
            </a:r>
            <a:endParaRPr kumimoji="1" lang="ja-JP" altLang="en-US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8CDE9D28-8D30-49DD-AB94-FADFCBC6B397}"/>
              </a:ext>
            </a:extLst>
          </p:cNvPr>
          <p:cNvSpPr txBox="1"/>
          <p:nvPr/>
        </p:nvSpPr>
        <p:spPr>
          <a:xfrm>
            <a:off x="-22805" y="23615"/>
            <a:ext cx="3130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Additional file 1: </a:t>
            </a:r>
            <a:r>
              <a:rPr kumimoji="1" lang="en-US" altLang="ja-JP" dirty="0"/>
              <a:t>Figure </a:t>
            </a:r>
            <a:r>
              <a:rPr kumimoji="1" lang="en-US" altLang="ja-JP" dirty="0" err="1" smtClean="0"/>
              <a:t>S1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311814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xmlns="" id="{F5F0DB7D-7AB5-4630-B51D-2E5442399D9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0829740"/>
              </p:ext>
            </p:extLst>
          </p:nvPr>
        </p:nvGraphicFramePr>
        <p:xfrm>
          <a:off x="11395" y="500441"/>
          <a:ext cx="3471003" cy="40432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xmlns="" id="{E3C87ADE-7A1F-471A-AF44-53C6E19D473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273381"/>
              </p:ext>
            </p:extLst>
          </p:nvPr>
        </p:nvGraphicFramePr>
        <p:xfrm>
          <a:off x="3235858" y="439161"/>
          <a:ext cx="3471003" cy="4043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xmlns="" id="{1FCDB34B-1D56-42EC-9A2E-A1EFA18965F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4718241"/>
              </p:ext>
            </p:extLst>
          </p:nvPr>
        </p:nvGraphicFramePr>
        <p:xfrm>
          <a:off x="11398" y="4616073"/>
          <a:ext cx="3471000" cy="40386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xmlns="" id="{4ACF8852-4E5A-4882-8A7C-3CA7DC62963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182918"/>
              </p:ext>
            </p:extLst>
          </p:nvPr>
        </p:nvGraphicFramePr>
        <p:xfrm>
          <a:off x="3415692" y="4666202"/>
          <a:ext cx="3453703" cy="40386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A7F74ACB-2E9C-4260-9E41-47592505C07E}"/>
              </a:ext>
            </a:extLst>
          </p:cNvPr>
          <p:cNvSpPr txBox="1"/>
          <p:nvPr/>
        </p:nvSpPr>
        <p:spPr>
          <a:xfrm>
            <a:off x="-22805" y="23615"/>
            <a:ext cx="3130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Additional file 1: </a:t>
            </a:r>
            <a:r>
              <a:rPr kumimoji="1" lang="en-US" altLang="ja-JP" dirty="0"/>
              <a:t>Figure </a:t>
            </a:r>
            <a:r>
              <a:rPr kumimoji="1" lang="en-US" altLang="ja-JP" dirty="0" err="1" smtClean="0"/>
              <a:t>S2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591904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A7F74ACB-2E9C-4260-9E41-47592505C07E}"/>
              </a:ext>
            </a:extLst>
          </p:cNvPr>
          <p:cNvSpPr txBox="1"/>
          <p:nvPr/>
        </p:nvSpPr>
        <p:spPr>
          <a:xfrm>
            <a:off x="-22805" y="23615"/>
            <a:ext cx="3130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Additional file 3: </a:t>
            </a:r>
            <a:r>
              <a:rPr kumimoji="1" lang="en-US" altLang="ja-JP" dirty="0"/>
              <a:t>Figure </a:t>
            </a:r>
            <a:r>
              <a:rPr kumimoji="1" lang="en-US" altLang="ja-JP" smtClean="0"/>
              <a:t>S3</a:t>
            </a:r>
            <a:endParaRPr kumimoji="1" lang="ja-JP" altLang="en-US" dirty="0"/>
          </a:p>
        </p:txBody>
      </p:sp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5636924"/>
              </p:ext>
            </p:extLst>
          </p:nvPr>
        </p:nvGraphicFramePr>
        <p:xfrm>
          <a:off x="533400" y="797623"/>
          <a:ext cx="2743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53043473"/>
              </p:ext>
            </p:extLst>
          </p:nvPr>
        </p:nvGraphicFramePr>
        <p:xfrm>
          <a:off x="3581400" y="797623"/>
          <a:ext cx="2743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58664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_Gothic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68</TotalTime>
  <Words>53</Words>
  <Application>Microsoft Office PowerPoint</Application>
  <PresentationFormat>On-screen Show (4:3)</PresentationFormat>
  <Paragraphs>2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ＭＳ Ｐゴシック</vt:lpstr>
      <vt:lpstr>Arial</vt:lpstr>
      <vt:lpstr>Office テーマ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堂國 良太</dc:creator>
  <cp:lastModifiedBy>Janani G.</cp:lastModifiedBy>
  <cp:revision>94</cp:revision>
  <dcterms:created xsi:type="dcterms:W3CDTF">2018-11-13T02:41:26Z</dcterms:created>
  <dcterms:modified xsi:type="dcterms:W3CDTF">2020-12-07T10:43:44Z</dcterms:modified>
</cp:coreProperties>
</file>